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7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ui Yiu CHOOK" initials="CYC" lastIdx="1" clrIdx="0"/>
  <p:cmAuthor id="2" name="CHOOK, Chui Yiu" initials="CCY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1FFB"/>
    <a:srgbClr val="0000FE"/>
    <a:srgbClr val="666666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88" autoAdjust="0"/>
    <p:restoredTop sz="95108"/>
  </p:normalViewPr>
  <p:slideViewPr>
    <p:cSldViewPr snapToGrid="0">
      <p:cViewPr varScale="1">
        <p:scale>
          <a:sx n="49" d="100"/>
          <a:sy n="49" d="100"/>
        </p:scale>
        <p:origin x="2562" y="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OOK, Chui Yiu" userId="0a31c0e3-f0b3-450b-8e5c-f0fcdbb593cd" providerId="ADAL" clId="{5784D0EA-D690-43F2-A533-DCEB060D94B5}"/>
    <pc:docChg chg="modSld">
      <pc:chgData name="CHOOK, Chui Yiu" userId="0a31c0e3-f0b3-450b-8e5c-f0fcdbb593cd" providerId="ADAL" clId="{5784D0EA-D690-43F2-A533-DCEB060D94B5}" dt="2021-03-19T03:50:20.103" v="3" actId="14100"/>
      <pc:docMkLst>
        <pc:docMk/>
      </pc:docMkLst>
      <pc:sldChg chg="modSp mod">
        <pc:chgData name="CHOOK, Chui Yiu" userId="0a31c0e3-f0b3-450b-8e5c-f0fcdbb593cd" providerId="ADAL" clId="{5784D0EA-D690-43F2-A533-DCEB060D94B5}" dt="2021-03-19T03:50:20.103" v="3" actId="14100"/>
        <pc:sldMkLst>
          <pc:docMk/>
          <pc:sldMk cId="529280132" sldId="275"/>
        </pc:sldMkLst>
        <pc:spChg chg="mod">
          <ac:chgData name="CHOOK, Chui Yiu" userId="0a31c0e3-f0b3-450b-8e5c-f0fcdbb593cd" providerId="ADAL" clId="{5784D0EA-D690-43F2-A533-DCEB060D94B5}" dt="2021-03-19T03:50:20.103" v="3" actId="14100"/>
          <ac:spMkLst>
            <pc:docMk/>
            <pc:sldMk cId="529280132" sldId="275"/>
            <ac:spMk id="21" creationId="{D0B82C7E-3C74-4D9B-B9A2-F4A67A711DFD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6089D1-496F-420C-89FC-22BEDCC6186E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191951-DE0E-43B0-A0E7-6540F1BB18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65473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TW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68544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95647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34535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30669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TW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11883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07129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TW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TW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15665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27617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8711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TW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20688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TW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TW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39161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TW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TW"/>
              <a:t>Click to edit Master text styles</a:t>
            </a:r>
          </a:p>
          <a:p>
            <a:pPr lvl="1"/>
            <a:r>
              <a:rPr lang="en-US" altLang="zh-TW"/>
              <a:t>Second level</a:t>
            </a:r>
          </a:p>
          <a:p>
            <a:pPr lvl="2"/>
            <a:r>
              <a:rPr lang="en-US" altLang="zh-TW"/>
              <a:t>Third level</a:t>
            </a:r>
          </a:p>
          <a:p>
            <a:pPr lvl="3"/>
            <a:r>
              <a:rPr lang="en-US" altLang="zh-TW"/>
              <a:t>Fourth level</a:t>
            </a:r>
          </a:p>
          <a:p>
            <a:pPr lvl="4"/>
            <a:r>
              <a:rPr lang="en-US" altLang="zh-TW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844F1-A643-47ED-9D3D-A2DBF5EA6C28}" type="datetimeFigureOut">
              <a:rPr lang="zh-TW" altLang="en-US" smtClean="0"/>
              <a:t>2021/6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AB83F-99CD-4AA6-8284-1CA63B6E92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703502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xmlns="" id="{972CE822-C6DB-4116-A2FF-3585BAE7C3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1036693"/>
              </p:ext>
            </p:extLst>
          </p:nvPr>
        </p:nvGraphicFramePr>
        <p:xfrm>
          <a:off x="362227" y="102045"/>
          <a:ext cx="2887663" cy="2687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Prism 8" r:id="rId3" imgW="3807369" imgH="3543944" progId="Prism8.Document">
                  <p:embed/>
                </p:oleObj>
              </mc:Choice>
              <mc:Fallback>
                <p:oleObj name="Prism 8" r:id="rId3" imgW="3807369" imgH="3543944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xmlns="" id="{972CE822-C6DB-4116-A2FF-3585BAE7C3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2227" y="102045"/>
                        <a:ext cx="2887663" cy="2687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DD61151-05AD-40F4-9A39-A5719E1146A6}"/>
              </a:ext>
            </a:extLst>
          </p:cNvPr>
          <p:cNvSpPr txBox="1"/>
          <p:nvPr/>
        </p:nvSpPr>
        <p:spPr>
          <a:xfrm>
            <a:off x="228919" y="107952"/>
            <a:ext cx="266616" cy="367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xmlns="" id="{6DBBF815-7AF2-47A0-8911-3D80296F45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4671096"/>
              </p:ext>
            </p:extLst>
          </p:nvPr>
        </p:nvGraphicFramePr>
        <p:xfrm>
          <a:off x="3270233" y="102046"/>
          <a:ext cx="2923557" cy="27315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Prism 8" r:id="rId5" imgW="3897378" imgH="3642957" progId="Prism8.Document">
                  <p:embed/>
                </p:oleObj>
              </mc:Choice>
              <mc:Fallback>
                <p:oleObj name="Prism 8" r:id="rId5" imgW="3897378" imgH="3642957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xmlns="" id="{6DBBF815-7AF2-47A0-8911-3D80296F453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70233" y="102046"/>
                        <a:ext cx="2923557" cy="27315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8494B1B6-078F-4CAB-8EA6-0F9AE22EBCDF}"/>
              </a:ext>
            </a:extLst>
          </p:cNvPr>
          <p:cNvSpPr txBox="1"/>
          <p:nvPr/>
        </p:nvSpPr>
        <p:spPr>
          <a:xfrm>
            <a:off x="3136924" y="107952"/>
            <a:ext cx="266616" cy="367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xmlns="" id="{FD2FA8C4-4B41-4CF8-84B0-C5E407006A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2486013"/>
              </p:ext>
            </p:extLst>
          </p:nvPr>
        </p:nvGraphicFramePr>
        <p:xfrm>
          <a:off x="362227" y="3037922"/>
          <a:ext cx="4276725" cy="2682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Prism 8" r:id="rId7" imgW="5866409" imgH="3682562" progId="Prism8.Document">
                  <p:embed/>
                </p:oleObj>
              </mc:Choice>
              <mc:Fallback>
                <p:oleObj name="Prism 8" r:id="rId7" imgW="5866409" imgH="3682562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xmlns="" id="{FD2FA8C4-4B41-4CF8-84B0-C5E407006A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62227" y="3037922"/>
                        <a:ext cx="4276725" cy="2682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FF548D3D-ECC0-4EED-BFC6-DD3CB802DD3B}"/>
              </a:ext>
            </a:extLst>
          </p:cNvPr>
          <p:cNvSpPr txBox="1"/>
          <p:nvPr/>
        </p:nvSpPr>
        <p:spPr>
          <a:xfrm>
            <a:off x="228919" y="3037922"/>
            <a:ext cx="266616" cy="367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xmlns="" id="{D0B82C7E-3C74-4D9B-B9A2-F4A67A711DFD}"/>
              </a:ext>
            </a:extLst>
          </p:cNvPr>
          <p:cNvSpPr/>
          <p:nvPr/>
        </p:nvSpPr>
        <p:spPr>
          <a:xfrm>
            <a:off x="228919" y="5868087"/>
            <a:ext cx="6006912" cy="13819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7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altLang="zh-TW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.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zh-TW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rocodile blood does not cause toxicity to C57BL/6J mice and mBMECs. 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ody weight (A), and non-fasting blood glucose level (B) of C57BL/6J mice treated with different doses of crocodile blood via oral gavage for 5 weeks (</a:t>
            </a:r>
            <a:r>
              <a:rPr lang="en-US" altLang="zh-TW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= 5). Effects of CBSF on the cell viability of mBMECs assessed by XTT Assay (</a:t>
            </a:r>
            <a:r>
              <a:rPr lang="en-US" altLang="zh-TW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= 8) (C). Data are represented in </a:t>
            </a:r>
            <a:r>
              <a:rPr lang="en-US" altLang="zh-TW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means ± SEM. 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BSF, crocodile blood soluble fraction; mBMECs, mouse brain microvascular endothelial cells.</a:t>
            </a:r>
            <a:endParaRPr lang="zh-TW" altLang="zh-TW" sz="12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9280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ADE787D56291D4DA175FF1553A71614" ma:contentTypeVersion="13" ma:contentTypeDescription="Create a new document." ma:contentTypeScope="" ma:versionID="d5e30c97a7b705a77504a05530bdd99b">
  <xsd:schema xmlns:xsd="http://www.w3.org/2001/XMLSchema" xmlns:xs="http://www.w3.org/2001/XMLSchema" xmlns:p="http://schemas.microsoft.com/office/2006/metadata/properties" xmlns:ns3="d7e037cb-8c19-4d7f-9769-8197b6cd3407" xmlns:ns4="7a94b284-e01b-4506-b47d-5e110868603f" targetNamespace="http://schemas.microsoft.com/office/2006/metadata/properties" ma:root="true" ma:fieldsID="7551527c264385c66926fb0ecf720908" ns3:_="" ns4:_="">
    <xsd:import namespace="d7e037cb-8c19-4d7f-9769-8197b6cd3407"/>
    <xsd:import namespace="7a94b284-e01b-4506-b47d-5e110868603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EventHashCode" minOccurs="0"/>
                <xsd:element ref="ns3:MediaServiceGenerationTim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7e037cb-8c19-4d7f-9769-8197b6cd340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a94b284-e01b-4506-b47d-5e110868603f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F250D64-17E9-4881-BB17-C061F2A20AF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B7D3028-B3BC-4A39-A5A6-448B01603A8C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2F9FACAD-8AE8-4C71-BC7A-940C0474051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7e037cb-8c19-4d7f-9769-8197b6cd3407"/>
    <ds:schemaRef ds:uri="7a94b284-e01b-4506-b47d-5e110868603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14</TotalTime>
  <Words>97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新細明體</vt:lpstr>
      <vt:lpstr>Times New Roman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mboo Chook</dc:creator>
  <cp:lastModifiedBy>Julie  Alolod Olano</cp:lastModifiedBy>
  <cp:revision>31</cp:revision>
  <dcterms:created xsi:type="dcterms:W3CDTF">2019-12-06T04:02:01Z</dcterms:created>
  <dcterms:modified xsi:type="dcterms:W3CDTF">2021-06-25T05:24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ADE787D56291D4DA175FF1553A71614</vt:lpwstr>
  </property>
</Properties>
</file>